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81" userDrawn="1">
          <p15:clr>
            <a:srgbClr val="A4A3A4"/>
          </p15:clr>
        </p15:guide>
        <p15:guide id="2" pos="1323" userDrawn="1">
          <p15:clr>
            <a:srgbClr val="A4A3A4"/>
          </p15:clr>
        </p15:guide>
        <p15:guide id="3" orient="horz" pos="504" userDrawn="1">
          <p15:clr>
            <a:srgbClr val="A4A3A4"/>
          </p15:clr>
        </p15:guide>
        <p15:guide id="4" pos="3840" userDrawn="1">
          <p15:clr>
            <a:srgbClr val="A4A3A4"/>
          </p15:clr>
        </p15:guide>
        <p15:guide id="5" orient="horz" pos="3657" userDrawn="1">
          <p15:clr>
            <a:srgbClr val="A4A3A4"/>
          </p15:clr>
        </p15:guide>
        <p15:guide id="6" orient="horz" pos="3725" userDrawn="1">
          <p15:clr>
            <a:srgbClr val="A4A3A4"/>
          </p15:clr>
        </p15:guide>
        <p15:guide id="7" orient="horz" pos="413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eeJoong Lee" initials="Lee" lastIdx="4" clrIdx="0">
    <p:extLst>
      <p:ext uri="{19B8F6BF-5375-455C-9EA6-DF929625EA0E}">
        <p15:presenceInfo xmlns:p15="http://schemas.microsoft.com/office/powerpoint/2012/main" userId="HeeJoong Le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141" autoAdjust="0"/>
  </p:normalViewPr>
  <p:slideViewPr>
    <p:cSldViewPr snapToGrid="0">
      <p:cViewPr varScale="1">
        <p:scale>
          <a:sx n="77" d="100"/>
          <a:sy n="77" d="100"/>
        </p:scale>
        <p:origin x="806" y="72"/>
      </p:cViewPr>
      <p:guideLst>
        <p:guide orient="horz" pos="981"/>
        <p:guide pos="1323"/>
        <p:guide orient="horz" pos="504"/>
        <p:guide pos="3840"/>
        <p:guide orient="horz" pos="3657"/>
        <p:guide orient="horz" pos="3725"/>
        <p:guide orient="horz" pos="413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B55E22-3B9A-4D2C-A739-37567EA8C95B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29D4F8-23FB-4C07-A8F0-B30230CBB7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288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atinLnBrk="1"/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29D4F8-23FB-4C07-A8F0-B30230CBB7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957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7551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296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1993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75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972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86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958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80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639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8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53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F2E19-65CB-45E5-A0C2-E70407257811}" type="datetimeFigureOut">
              <a:rPr lang="ko-KR" altLang="en-US" smtClean="0"/>
              <a:t>2023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3E60E-4E2F-4490-A24E-49126FC537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1818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27313" y="333375"/>
            <a:ext cx="105373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.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s at time of ovarian cancer diagnosis according to receipt of HRT.</a:t>
            </a:r>
            <a:endParaRPr lang="en-US" altLang="ko-K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그룹 6"/>
          <p:cNvGrpSpPr/>
          <p:nvPr/>
        </p:nvGrpSpPr>
        <p:grpSpPr>
          <a:xfrm>
            <a:off x="2340146" y="1238250"/>
            <a:ext cx="7511707" cy="5427663"/>
            <a:chOff x="2422868" y="1356360"/>
            <a:chExt cx="7273597" cy="5204778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22868" y="1382850"/>
              <a:ext cx="3673132" cy="5178288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05939" y="1356360"/>
              <a:ext cx="3590526" cy="520245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9117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18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unjeong Ji</dc:creator>
  <cp:lastModifiedBy>Banghyun Lee</cp:lastModifiedBy>
  <cp:revision>37</cp:revision>
  <dcterms:created xsi:type="dcterms:W3CDTF">2022-01-28T09:16:13Z</dcterms:created>
  <dcterms:modified xsi:type="dcterms:W3CDTF">2023-02-06T09:27:16Z</dcterms:modified>
</cp:coreProperties>
</file>